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75699" autoAdjust="0"/>
  </p:normalViewPr>
  <p:slideViewPr>
    <p:cSldViewPr snapToGrid="0">
      <p:cViewPr varScale="1">
        <p:scale>
          <a:sx n="58" d="100"/>
          <a:sy n="58" d="100"/>
        </p:scale>
        <p:origin x="-1206" y="-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CA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94A76F5-9347-4581-9EED-32CB555EE33B}" type="datetimeFigureOut">
              <a:rPr lang="fr-CA" smtClean="0"/>
              <a:pPr/>
              <a:t>2018-01-12</a:t>
            </a:fld>
            <a:endParaRPr lang="fr-CA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CA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0539078-B2D5-4A60-A62A-B444EC0E9DA0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xmlns="" val="11990813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 60-year-old man presenting with a right-to-left intra-atrial shunt (black arrow), as shown by a jet flow of non-enhanced blood in the left atrium (arrow).  A 7-mm ostium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ecundum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trial septal defect with bidirectional flow was confirmed at trans-esophageal echocardiography.  The patient underwent minimally invasive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ranscatheter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losure with a septal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ccluder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endParaRPr lang="fr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0539078-B2D5-4A60-A62A-B444EC0E9DA0}" type="slidenum">
              <a:rPr lang="fr-CA" smtClean="0"/>
              <a:pPr/>
              <a:t>1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xmlns="" val="31247014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r le style des sous-titres du masque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E00C1F-946C-4921-AD88-2564A8031D60}" type="datetimeFigureOut">
              <a:rPr lang="fr-CA" smtClean="0"/>
              <a:pPr/>
              <a:t>2018-01-12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B13B8-C351-4884-A369-C3BB98026AA4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xmlns="" val="35847938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E00C1F-946C-4921-AD88-2564A8031D60}" type="datetimeFigureOut">
              <a:rPr lang="fr-CA" smtClean="0"/>
              <a:pPr/>
              <a:t>2018-01-12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B13B8-C351-4884-A369-C3BB98026AA4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xmlns="" val="37616448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E00C1F-946C-4921-AD88-2564A8031D60}" type="datetimeFigureOut">
              <a:rPr lang="fr-CA" smtClean="0"/>
              <a:pPr/>
              <a:t>2018-01-12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B13B8-C351-4884-A369-C3BB98026AA4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xmlns="" val="32914919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E00C1F-946C-4921-AD88-2564A8031D60}" type="datetimeFigureOut">
              <a:rPr lang="fr-CA" smtClean="0"/>
              <a:pPr/>
              <a:t>2018-01-12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B13B8-C351-4884-A369-C3BB98026AA4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xmlns="" val="30930648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E00C1F-946C-4921-AD88-2564A8031D60}" type="datetimeFigureOut">
              <a:rPr lang="fr-CA" smtClean="0"/>
              <a:pPr/>
              <a:t>2018-01-12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B13B8-C351-4884-A369-C3BB98026AA4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xmlns="" val="6294360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E00C1F-946C-4921-AD88-2564A8031D60}" type="datetimeFigureOut">
              <a:rPr lang="fr-CA" smtClean="0"/>
              <a:pPr/>
              <a:t>2018-01-12</a:t>
            </a:fld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B13B8-C351-4884-A369-C3BB98026AA4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xmlns="" val="9148947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E00C1F-946C-4921-AD88-2564A8031D60}" type="datetimeFigureOut">
              <a:rPr lang="fr-CA" smtClean="0"/>
              <a:pPr/>
              <a:t>2018-01-12</a:t>
            </a:fld>
            <a:endParaRPr lang="fr-CA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B13B8-C351-4884-A369-C3BB98026AA4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xmlns="" val="26379490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E00C1F-946C-4921-AD88-2564A8031D60}" type="datetimeFigureOut">
              <a:rPr lang="fr-CA" smtClean="0"/>
              <a:pPr/>
              <a:t>2018-01-12</a:t>
            </a:fld>
            <a:endParaRPr lang="fr-CA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B13B8-C351-4884-A369-C3BB98026AA4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xmlns="" val="18730955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E00C1F-946C-4921-AD88-2564A8031D60}" type="datetimeFigureOut">
              <a:rPr lang="fr-CA" smtClean="0"/>
              <a:pPr/>
              <a:t>2018-01-12</a:t>
            </a:fld>
            <a:endParaRPr lang="fr-CA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B13B8-C351-4884-A369-C3BB98026AA4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xmlns="" val="10200896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E00C1F-946C-4921-AD88-2564A8031D60}" type="datetimeFigureOut">
              <a:rPr lang="fr-CA" smtClean="0"/>
              <a:pPr/>
              <a:t>2018-01-12</a:t>
            </a:fld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B13B8-C351-4884-A369-C3BB98026AA4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xmlns="" val="8916285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CA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E00C1F-946C-4921-AD88-2564A8031D60}" type="datetimeFigureOut">
              <a:rPr lang="fr-CA" smtClean="0"/>
              <a:pPr/>
              <a:t>2018-01-12</a:t>
            </a:fld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B13B8-C351-4884-A369-C3BB98026AA4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xmlns="" val="41396171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E00C1F-946C-4921-AD88-2564A8031D60}" type="datetimeFigureOut">
              <a:rPr lang="fr-CA" smtClean="0"/>
              <a:pPr/>
              <a:t>2018-01-12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8B13B8-C351-4884-A369-C3BB98026AA4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xmlns="" val="28101947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1" name="Connecteur droit avec flèche 10"/>
          <p:cNvCxnSpPr>
            <a:cxnSpLocks/>
          </p:cNvCxnSpPr>
          <p:nvPr/>
        </p:nvCxnSpPr>
        <p:spPr>
          <a:xfrm rot="-60000" flipH="1">
            <a:off x="9741871" y="3721395"/>
            <a:ext cx="422855" cy="11632"/>
          </a:xfrm>
          <a:prstGeom prst="straightConnector1">
            <a:avLst/>
          </a:prstGeom>
          <a:ln w="57150" cmpd="sng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Connecteur droit avec flèche 18"/>
          <p:cNvCxnSpPr>
            <a:cxnSpLocks/>
          </p:cNvCxnSpPr>
          <p:nvPr/>
        </p:nvCxnSpPr>
        <p:spPr>
          <a:xfrm rot="-1440000" flipH="1">
            <a:off x="5290364" y="2746747"/>
            <a:ext cx="422855" cy="11632"/>
          </a:xfrm>
          <a:prstGeom prst="straightConnector1">
            <a:avLst/>
          </a:prstGeom>
          <a:ln w="57150" cmpd="sng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ZoneTexte 3"/>
          <p:cNvSpPr txBox="1">
            <a:spLocks noChangeArrowheads="1"/>
          </p:cNvSpPr>
          <p:nvPr/>
        </p:nvSpPr>
        <p:spPr bwMode="auto">
          <a:xfrm>
            <a:off x="3537538" y="558631"/>
            <a:ext cx="184731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eaLnBrk="1" fontAlgn="base" hangingPunct="1">
              <a:spcBef>
                <a:spcPct val="0"/>
              </a:spcBef>
              <a:spcAft>
                <a:spcPct val="0"/>
              </a:spcAft>
            </a:pPr>
            <a:endParaRPr lang="fr-CA" altLang="fr-FR" sz="2800" b="1" dirty="0">
              <a:solidFill>
                <a:prstClr val="white"/>
              </a:solidFill>
              <a:cs typeface="Arial" panose="020B0604020202020204" pitchFamily="34" charset="0"/>
            </a:endParaRPr>
          </a:p>
        </p:txBody>
      </p:sp>
      <p:sp>
        <p:nvSpPr>
          <p:cNvPr id="21" name="ZoneTexte 3"/>
          <p:cNvSpPr txBox="1">
            <a:spLocks noChangeArrowheads="1"/>
          </p:cNvSpPr>
          <p:nvPr/>
        </p:nvSpPr>
        <p:spPr bwMode="auto">
          <a:xfrm>
            <a:off x="6770024" y="2331283"/>
            <a:ext cx="444352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eaLnBrk="1" fontAlgn="base" hangingPunct="1">
              <a:spcBef>
                <a:spcPct val="0"/>
              </a:spcBef>
              <a:spcAft>
                <a:spcPct val="0"/>
              </a:spcAft>
            </a:pPr>
            <a:r>
              <a:rPr lang="fr-CA" altLang="fr-FR" sz="2800" b="1" dirty="0">
                <a:cs typeface="Arial" panose="020B0604020202020204" pitchFamily="34" charset="0"/>
              </a:rPr>
              <a:t>B</a:t>
            </a:r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3866508" y="262817"/>
            <a:ext cx="4660151" cy="4660151"/>
          </a:xfrm>
          <a:prstGeom prst="rect">
            <a:avLst/>
          </a:prstGeom>
        </p:spPr>
      </p:pic>
      <p:cxnSp>
        <p:nvCxnSpPr>
          <p:cNvPr id="23" name="Connecteur droit avec flèche 22"/>
          <p:cNvCxnSpPr>
            <a:cxnSpLocks/>
          </p:cNvCxnSpPr>
          <p:nvPr/>
        </p:nvCxnSpPr>
        <p:spPr>
          <a:xfrm flipH="1">
            <a:off x="5186732" y="4490203"/>
            <a:ext cx="422855" cy="11632"/>
          </a:xfrm>
          <a:prstGeom prst="straightConnector1">
            <a:avLst/>
          </a:prstGeom>
          <a:ln w="57150" cmpd="sng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ZoneTexte 2">
            <a:extLst>
              <a:ext uri="{FF2B5EF4-FFF2-40B4-BE49-F238E27FC236}">
                <a16:creationId xmlns:a16="http://schemas.microsoft.com/office/drawing/2014/main" xmlns="" id="{5B26B776-2BCB-4ECC-BF94-5AD25537F69F}"/>
              </a:ext>
            </a:extLst>
          </p:cNvPr>
          <p:cNvSpPr txBox="1"/>
          <p:nvPr/>
        </p:nvSpPr>
        <p:spPr>
          <a:xfrm>
            <a:off x="461342" y="5255561"/>
            <a:ext cx="1138610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b="1" dirty="0" err="1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lang="en-US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A 60-year-old man presenting with a right-to-left intra-atrial shunt (black arrow), as shown by a jet flow of non-enhanced blood in the left atrium (arrow).  A 7-mm ostium </a:t>
            </a:r>
            <a:r>
              <a:rPr lang="en-US" dirty="0" err="1">
                <a:solidFill>
                  <a:schemeClr val="bg1"/>
                </a:solidFill>
              </a:rPr>
              <a:t>secundum</a:t>
            </a:r>
            <a:r>
              <a:rPr lang="en-US" dirty="0">
                <a:solidFill>
                  <a:schemeClr val="bg1"/>
                </a:solidFill>
              </a:rPr>
              <a:t> atrial septal defect with bidirectional flow was confirmed at trans-esophageal echocardiography.  The patient underwent minimally invasive transcatheter closure with a septal </a:t>
            </a:r>
            <a:r>
              <a:rPr lang="en-US" dirty="0" err="1">
                <a:solidFill>
                  <a:schemeClr val="bg1"/>
                </a:solidFill>
              </a:rPr>
              <a:t>occluder</a:t>
            </a:r>
            <a:r>
              <a:rPr lang="en-US" dirty="0">
                <a:solidFill>
                  <a:schemeClr val="bg1"/>
                </a:solidFill>
              </a:rPr>
              <a:t>.</a:t>
            </a:r>
            <a:endParaRPr lang="fr-CA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9059795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4</TotalTime>
  <Words>122</Words>
  <Application>Microsoft Office PowerPoint</Application>
  <PresentationFormat>Custom</PresentationFormat>
  <Paragraphs>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hème Offic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arl Chartrand-Lefebvre</dc:creator>
  <cp:lastModifiedBy>0013357</cp:lastModifiedBy>
  <cp:revision>22</cp:revision>
  <dcterms:created xsi:type="dcterms:W3CDTF">2017-03-18T22:22:49Z</dcterms:created>
  <dcterms:modified xsi:type="dcterms:W3CDTF">2018-01-12T14:58:43Z</dcterms:modified>
</cp:coreProperties>
</file>